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02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839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53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640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312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57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846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898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392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882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62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424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9456A-937D-4307-A3CF-015FA2550CE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8D061-FB72-4F0F-B600-1EBF8945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050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4843104" y="944563"/>
            <a:ext cx="2583221" cy="4192587"/>
            <a:chOff x="1619261" y="1364368"/>
            <a:chExt cx="3731320" cy="6055959"/>
          </a:xfrm>
        </p:grpSpPr>
        <p:graphicFrame>
          <p:nvGraphicFramePr>
            <p:cNvPr id="5" name="对象 56">
              <a:extLst>
                <a:ext uri="{FF2B5EF4-FFF2-40B4-BE49-F238E27FC236}">
                  <a16:creationId xmlns:a16="http://schemas.microsoft.com/office/drawing/2014/main" id="{A3A29ED3-33CB-4E1F-B338-A344CF9AA2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01861032"/>
                </p:ext>
              </p:extLst>
            </p:nvPr>
          </p:nvGraphicFramePr>
          <p:xfrm>
            <a:off x="1619780" y="1364368"/>
            <a:ext cx="3538184" cy="30589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8" name="Prism 8" r:id="rId3" imgW="4212507" imgH="3647278" progId="Prism8.Document">
                    <p:embed/>
                  </p:oleObj>
                </mc:Choice>
                <mc:Fallback>
                  <p:oleObj name="Prism 8" r:id="rId3" imgW="4212507" imgH="364727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619780" y="1364368"/>
                          <a:ext cx="3538184" cy="30589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60">
              <a:extLst>
                <a:ext uri="{FF2B5EF4-FFF2-40B4-BE49-F238E27FC236}">
                  <a16:creationId xmlns:a16="http://schemas.microsoft.com/office/drawing/2014/main" id="{E9365362-4646-4A76-ABF6-9F2984580A6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03306773"/>
                </p:ext>
              </p:extLst>
            </p:nvPr>
          </p:nvGraphicFramePr>
          <p:xfrm>
            <a:off x="1658761" y="4531077"/>
            <a:ext cx="3691820" cy="2889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name="Prism 8" r:id="rId5" imgW="4236637" imgH="3316754" progId="Prism8.Document">
                    <p:embed/>
                  </p:oleObj>
                </mc:Choice>
                <mc:Fallback>
                  <p:oleObj name="Prism 8" r:id="rId5" imgW="4236637" imgH="331675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658761" y="4531077"/>
                          <a:ext cx="3691820" cy="2889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文本框 8">
              <a:extLst>
                <a:ext uri="{FF2B5EF4-FFF2-40B4-BE49-F238E27FC236}">
                  <a16:creationId xmlns:a16="http://schemas.microsoft.com/office/drawing/2014/main" id="{CC8E814D-D6F2-4C90-9A62-4921C5BAE13F}"/>
                </a:ext>
              </a:extLst>
            </p:cNvPr>
            <p:cNvSpPr txBox="1"/>
            <p:nvPr/>
          </p:nvSpPr>
          <p:spPr>
            <a:xfrm>
              <a:off x="1619261" y="1747601"/>
              <a:ext cx="414928" cy="379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8">
              <a:extLst>
                <a:ext uri="{FF2B5EF4-FFF2-40B4-BE49-F238E27FC236}">
                  <a16:creationId xmlns:a16="http://schemas.microsoft.com/office/drawing/2014/main" id="{485BA568-6DC6-4108-BF15-3AA515892CCD}"/>
                </a:ext>
              </a:extLst>
            </p:cNvPr>
            <p:cNvSpPr txBox="1"/>
            <p:nvPr/>
          </p:nvSpPr>
          <p:spPr>
            <a:xfrm>
              <a:off x="1619261" y="4411399"/>
              <a:ext cx="373109" cy="379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8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3990871" y="5210830"/>
            <a:ext cx="4152023" cy="13708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31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4. Ac2-26 alleviates inflammatory pain via FPR2 in </a:t>
            </a:r>
            <a:r>
              <a:rPr lang="en-US" altLang="zh-CN" sz="831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b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. </a:t>
            </a:r>
            <a:endParaRPr lang="zh-CN" altLang="zh-CN" sz="831" b="1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Quantitative analysis of the licking or biting duration over 60 min after injection of 1% formalin into the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indpaw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 (0-15 min: Ac2-26 versus scramble group, n=8, **P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&lt; 0.01; Boc2+Ac2-26 versus Ac2-26 group, n=8 *P &lt; 0.05; 15-60 min: Ac2-26 versus scramble group, n=8, ***P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&lt; 0.001; Boc2+Ac2-26 versus Ac2-26 group, n=8 **P &lt; 0.01; Two-way ANOVA,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dak’s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ltiple comparisons test, n=8 in each group). (B) Quantitative analysis of the withdrawal latency to radiant heat in Hargreaves test (Ac2-26 versus scramble group, n=10, **P &lt; 0.01; Boc2+Ac2-26 versus Ac2-26 group, n=10, **P &lt; 0.01; One-way ANOVA, post hoc Tukey’s multiple comparisons test) in 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 treated with after unilateral injection of CFA.</a:t>
            </a:r>
            <a:r>
              <a:rPr lang="en-US" altLang="zh-CN" sz="831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data are represented as mean</a:t>
            </a:r>
            <a:r>
              <a:rPr lang="zh-CN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.</a:t>
            </a:r>
            <a:endParaRPr lang="zh-CN" altLang="zh-CN" sz="831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TextBox 19">
            <a:extLst>
              <a:ext uri="{FF2B5EF4-FFF2-40B4-BE49-F238E27FC236}">
                <a16:creationId xmlns:a16="http://schemas.microsoft.com/office/drawing/2014/main" id="{1CF9F106-518D-4128-9C96-C908ED048F23}"/>
              </a:ext>
            </a:extLst>
          </p:cNvPr>
          <p:cNvSpPr txBox="1"/>
          <p:nvPr/>
        </p:nvSpPr>
        <p:spPr>
          <a:xfrm>
            <a:off x="3824458" y="176460"/>
            <a:ext cx="1285929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</a:t>
            </a:r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4" name="矩形 3"/>
          <p:cNvSpPr/>
          <p:nvPr/>
        </p:nvSpPr>
        <p:spPr>
          <a:xfrm>
            <a:off x="3824458" y="501400"/>
            <a:ext cx="4185674" cy="2414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96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c2-26 alleviates inflammatory pain via FPR2 in </a:t>
            </a:r>
            <a:r>
              <a:rPr lang="en-US" altLang="zh-CN" sz="969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969" b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96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. </a:t>
            </a:r>
            <a:endParaRPr lang="zh-CN" altLang="zh-CN" sz="969" b="1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5874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15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Theme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undarya NR.</dc:creator>
  <cp:lastModifiedBy>peilei</cp:lastModifiedBy>
  <cp:revision>7</cp:revision>
  <dcterms:created xsi:type="dcterms:W3CDTF">2021-08-17T15:11:24Z</dcterms:created>
  <dcterms:modified xsi:type="dcterms:W3CDTF">2021-08-20T05:45:35Z</dcterms:modified>
</cp:coreProperties>
</file>